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02" y="1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2192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9072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147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1165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89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428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3031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345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7140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2696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519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7CAB0-1374-4F2A-824B-A622592CD3FD}" type="datetimeFigureOut">
              <a:rPr lang="zh-CN" altLang="en-US" smtClean="0"/>
              <a:t>2018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7B940F-AB6E-4FA8-941F-F7B703F5F9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677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744494" y="1685597"/>
            <a:ext cx="8703012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4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</a:rPr>
              <a:t>The circular RNA profiles of colorectal tumor metastatic cells</a:t>
            </a:r>
            <a:endParaRPr lang="zh-CN" altLang="en-US" sz="440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744494" y="3784060"/>
            <a:ext cx="87030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ation 1</a:t>
            </a:r>
          </a:p>
        </p:txBody>
      </p:sp>
      <p:sp>
        <p:nvSpPr>
          <p:cNvPr id="4" name="矩形 3"/>
          <p:cNvSpPr/>
          <p:nvPr/>
        </p:nvSpPr>
        <p:spPr>
          <a:xfrm>
            <a:off x="1525621" y="4379041"/>
            <a:ext cx="91407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1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DEC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predicted to bind 69 CRC-related miRNAs as putative sponges</a:t>
            </a:r>
          </a:p>
        </p:txBody>
      </p:sp>
    </p:spTree>
    <p:extLst>
      <p:ext uri="{BB962C8B-B14F-4D97-AF65-F5344CB8AC3E}">
        <p14:creationId xmlns:p14="http://schemas.microsoft.com/office/powerpoint/2010/main" val="34450569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473413" y="682215"/>
            <a:ext cx="11245174" cy="5909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 the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DEC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we identified 251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hich harbor one or more miRNA response element for one out of 69 miRNAs previously identified to play a role in CRC (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eckovic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15; Wang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15;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i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17) (Supplementary Table S7) as potential candidates to affect the activity of these miRNAs (miRNA sponges).</a:t>
            </a:r>
          </a:p>
          <a:p>
            <a:pPr algn="just">
              <a:lnSpc>
                <a:spcPct val="150000"/>
              </a:lnSpc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In detail, sponges were first predicted by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etel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08), and further filtered based on some criteria: the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hich would be considered as potential miRNA sponges targeted miRNAs with the presence of conserved 8mer and 7mer sites that match the seed region of each miRNA (Lewis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05). On the other hand, targets of miRNAs were all experimentally validated, which were downloaded from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TarBase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hou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16).</a:t>
            </a:r>
          </a:p>
          <a:p>
            <a:pPr algn="just">
              <a:lnSpc>
                <a:spcPct val="150000"/>
              </a:lnSpc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Therefore, 69 CRC-relate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iRNA networks (Supplementary Table S7) have been identified. The miRNAs an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14/69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iRNA networks are all related to CRC tumor or CRC metastasis (Supplementary Table S7). Of the 251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DEC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124 came from metastasis-related genes or as sponges of one out of 69 miRNAs which target metastasis-related genes. As a consequence, 25 candidate CRC metastasis-relate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iRNA-mRNA networks were predicted (Supplementary Table S7). MicroRNAs such as miR21, miR96, and miR155, whose regulatory roles have been confirmed in CRC metastasis (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i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17; Wang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15; Yang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2016) are also included among the 25 CRC metastasis-related network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73413" y="223737"/>
            <a:ext cx="112451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ods and Results</a:t>
            </a:r>
          </a:p>
        </p:txBody>
      </p:sp>
    </p:spTree>
    <p:extLst>
      <p:ext uri="{BB962C8B-B14F-4D97-AF65-F5344CB8AC3E}">
        <p14:creationId xmlns:p14="http://schemas.microsoft.com/office/powerpoint/2010/main" val="6748792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73413" y="223737"/>
            <a:ext cx="112451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s</a:t>
            </a:r>
          </a:p>
        </p:txBody>
      </p:sp>
      <p:sp>
        <p:nvSpPr>
          <p:cNvPr id="3" name="矩形 2"/>
          <p:cNvSpPr/>
          <p:nvPr/>
        </p:nvSpPr>
        <p:spPr>
          <a:xfrm>
            <a:off x="473413" y="776205"/>
            <a:ext cx="11245174" cy="45520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4800" indent="-304800">
              <a:lnSpc>
                <a:spcPct val="115000"/>
              </a:lnSpc>
            </a:pPr>
            <a:r>
              <a:rPr lang="en-US" altLang="zh-CN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ečković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, and Kang. Y., (2015). Regulation of cancer metastasis by cell-free miRNAs. </a:t>
            </a:r>
            <a:r>
              <a:rPr lang="en-US" altLang="zh-CN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chimica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</a:t>
            </a:r>
            <a:r>
              <a:rPr lang="en-US" altLang="zh-CN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physica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a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855, 24-42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04800" indent="-304800">
              <a:lnSpc>
                <a:spcPct val="115000"/>
              </a:lnSpc>
            </a:pP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el, D., Wilson, M., </a:t>
            </a:r>
            <a:r>
              <a:rPr lang="en-US" altLang="zh-CN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bow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., Marks, D. S., and Sander, C. (2008). The microRNA.org resource: Targets and expression. 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ic Acids Res.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6, 149-153. 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marL="304800" indent="-304800">
              <a:lnSpc>
                <a:spcPct val="115000"/>
              </a:lnSpc>
            </a:pP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u, C. H., Chang, N. W., Shrestha, S., Hsu, S. Da, Lin, Y. L., Lee, W. H., 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6). </a:t>
            </a:r>
            <a:r>
              <a:rPr lang="en-US" altLang="zh-CN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TarBase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16: Updates to the experimentally validated miRNA-target interactions database. 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ic Acids Res.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4, D239-D247. 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marL="304800" indent="-304800">
              <a:lnSpc>
                <a:spcPct val="115000"/>
              </a:lnSpc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wis, B.P., Burge C.B., and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tel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.P. (2005). Conserved seed pairing, often flanked by adenosines, indicates that thousands of human genes are microRNA targets.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.</a:t>
            </a:r>
            <a:r>
              <a:rPr lang="en-US" altLang="zh-CN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0(1), 15-20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marL="304800" indent="-304800">
              <a:lnSpc>
                <a:spcPct val="115000"/>
              </a:lnSpc>
            </a:pPr>
            <a:r>
              <a:rPr lang="en-US" altLang="zh-CN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in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., Li, T., van Dam, H., Zhou, F., and Zhang, L. (2017). Molecular insights into </a:t>
            </a:r>
            <a:r>
              <a:rPr lang="en-US" altLang="zh-CN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ur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astasis: tracing the dominant events. 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 </a:t>
            </a:r>
            <a:r>
              <a:rPr lang="en-US" altLang="zh-CN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ol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1, 567-577. 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marL="304800" indent="-304800">
              <a:lnSpc>
                <a:spcPct val="115000"/>
              </a:lnSpc>
            </a:pP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ng, J., Song, Y.X., Ma, B., Wang, J.-J., Sun, J.X., Chen, X.W., 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5). Regulatory Roles of Non-Coding RNAs in Colorectal Cancer. 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. J. Mol. Sci.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6, 19886-19919. 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marL="304800" indent="-304800">
              <a:lnSpc>
                <a:spcPct val="115000"/>
              </a:lnSpc>
            </a:pP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ng, W., Du, W. W., Li, X., Yee, A. J., and Yang, B. B. (2016). Foxo3 activity promoted by non-coding effects of circular RNA and Foxo3 pseudogene in the inhibition of tumor growth and angiogenesis. </a:t>
            </a:r>
            <a:r>
              <a:rPr lang="en-US" altLang="zh-CN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cogene</a:t>
            </a:r>
            <a:r>
              <a:rPr lang="en-US" altLang="zh-CN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5, 3919-3931. </a:t>
            </a:r>
            <a:endParaRPr lang="zh-CN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8380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629</Words>
  <Application>Microsoft Office PowerPoint</Application>
  <PresentationFormat>宽屏</PresentationFormat>
  <Paragraphs>15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J Chu</dc:creator>
  <cp:lastModifiedBy>QJ Chu</cp:lastModifiedBy>
  <cp:revision>4</cp:revision>
  <dcterms:created xsi:type="dcterms:W3CDTF">2018-01-30T07:44:13Z</dcterms:created>
  <dcterms:modified xsi:type="dcterms:W3CDTF">2018-01-30T11:23:41Z</dcterms:modified>
</cp:coreProperties>
</file>